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6" r:id="rId2"/>
    <p:sldId id="259" r:id="rId3"/>
    <p:sldId id="257" r:id="rId4"/>
    <p:sldId id="258" r:id="rId5"/>
    <p:sldId id="260" r:id="rId6"/>
    <p:sldId id="262" r:id="rId7"/>
    <p:sldId id="268" r:id="rId8"/>
    <p:sldId id="261" r:id="rId9"/>
    <p:sldId id="263" r:id="rId10"/>
    <p:sldId id="264" r:id="rId11"/>
    <p:sldId id="266" r:id="rId12"/>
    <p:sldId id="267" r:id="rId13"/>
    <p:sldId id="265" r:id="rId14"/>
    <p:sldId id="271" r:id="rId15"/>
    <p:sldId id="269" r:id="rId16"/>
    <p:sldId id="270" r:id="rId17"/>
    <p:sldId id="272" r:id="rId18"/>
    <p:sldId id="273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79487" autoAdjust="0"/>
  </p:normalViewPr>
  <p:slideViewPr>
    <p:cSldViewPr snapToGrid="0">
      <p:cViewPr varScale="1">
        <p:scale>
          <a:sx n="90" d="100"/>
          <a:sy n="90" d="100"/>
        </p:scale>
        <p:origin x="1376" y="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008FCC-B59F-4E8C-A1E8-6AE23BA18752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6ECA5C-6609-4892-A12F-AE89CFBED09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95794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If there are any positive findings, be specific and comment on its location and size/severit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758271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Tenderness, warmth, swelling, erythema</a:t>
            </a:r>
          </a:p>
          <a:p>
            <a:r>
              <a:rPr lang="en-AU" dirty="0"/>
              <a:t>Compare sid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4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13514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Technically, to accurately and reliably measure ROM you should use a goniometer (mentioning this will be good). For time’s sake, we will be measuring via observation.</a:t>
            </a:r>
          </a:p>
          <a:p>
            <a:endParaRPr lang="en-AU" dirty="0"/>
          </a:p>
          <a:p>
            <a:r>
              <a:rPr lang="en-AU" dirty="0"/>
              <a:t>Active ROM is testing the strength and capacity of the patient’s active tissues to move their limb, restrictions in active ROM may be due to strength deficits secondary to a musculotendinous injury, neurological deficits, however, can also be reduced due to a restriction in the passive structures of a joint (shoulder capsule, ligamentous injury, swelling, neuromuscular inhibition secondary to pain).</a:t>
            </a:r>
          </a:p>
          <a:p>
            <a:endParaRPr lang="en-AU" dirty="0"/>
          </a:p>
          <a:p>
            <a:r>
              <a:rPr lang="en-AU" dirty="0"/>
              <a:t>Passive ROM is testing for ROM limitations due to stiffness and/or passive restriction (e.g. frozen shoulder/capsulitis, osteoarthritis, swelling/effusion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5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2446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bacromial space: subacromial bursa, RC tendons, LH biceps tendon</a:t>
            </a:r>
          </a:p>
          <a:p>
            <a:r>
              <a:rPr lang="en-US" dirty="0"/>
              <a:t>Inflammation can occur with one or more of these structures secondary to repetitive use or trauma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6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77508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Highlighted sections are assessed in the rubric, others are extras that you should be aware of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8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257860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+ distal biceps tendon anteriorly</a:t>
            </a:r>
          </a:p>
          <a:p>
            <a:r>
              <a:rPr lang="en-AU" dirty="0"/>
              <a:t>Warmth, tenderness, erythema, effusion/swelling</a:t>
            </a:r>
          </a:p>
          <a:p>
            <a:r>
              <a:rPr lang="en-AU" dirty="0"/>
              <a:t>Compare sid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9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4035341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ennis elbow vs. Golfer’s elbow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1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59534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MCL: anterior, posterior, transverse bundles</a:t>
            </a:r>
          </a:p>
          <a:p>
            <a:r>
              <a:rPr lang="en-AU" dirty="0"/>
              <a:t>LCL complex: lateral UCL, RCL, accessory collateral ligament</a:t>
            </a:r>
          </a:p>
          <a:p>
            <a:endParaRPr lang="en-A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dirty="0"/>
              <a:t>Highlighted sections are assessed in the rubric, others are extras that you should be aware of. </a:t>
            </a: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6ECA5C-6609-4892-A12F-AE89CFBED098}" type="slidenum">
              <a:rPr lang="en-AU" smtClean="0"/>
              <a:t>1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33211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AF6B5-821A-A260-2522-47B7B30499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AC4BBB-A79C-6FFA-AF09-0CEC617A7E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BEC57-FCFB-1B67-B369-6C0276497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2E9B1F-CA00-3AD8-7325-C6B36DD98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C70C03-B6D6-A756-806F-6CA5C2742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0307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BE164D-6C38-C666-E37E-021004BF52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6C7268-4243-EC94-21CD-C3AA6045C8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1620C-D72F-5CF5-9375-DCEB083C1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23D65-46A5-D88A-68FA-10301D7EE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478E1-CBDC-EBB8-9AFE-5A0CC09AD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06028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4C71629-CACF-D1BF-B841-72E46A4548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81B627-DC9C-8B1B-327D-6CA207674F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5B34E-F85B-0F51-40D7-2F992726E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D2FF32-3578-BF47-1A6E-3A03EA963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142A5E-D406-B9FA-C764-B86F31032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463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82273-6E29-0424-78FA-8E1ECF911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2C3110-32B3-1E5F-3AD4-4E615736AE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1FFD4C-30A4-E735-4E3F-CFDC7E2E8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233763-FEC8-D7A8-EEC9-B6A88A8AB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9F38D1-85DA-C968-5B74-76CC3E6A6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0808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930B1-158A-9EB1-A89F-6CCC150FA0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75A19E-014C-A0DD-0F6C-C72457199F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934C3B-088B-7017-841A-2EAF5614C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CBE4A0-7F07-D809-57CD-184DB6133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2104D3-657B-9786-594C-67CF35A92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82808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0138B-65F0-4BE4-2E1A-82B4A061A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038787-A5BA-18C2-1FF3-6FF656A3FC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A5A43F-40B2-D3E3-C62B-8B03A2F54E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AC2FDC-955F-5AF0-5CB0-C863A63F8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B5CAB0-9A71-BB9F-A7B8-2502D2ECF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F05BF6-7B8C-3AA2-3C8A-E23CF659C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96712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A51872-7F85-5458-0249-063BF0906C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89E075-7EB4-0730-2C12-9DFBA40D58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888604-E6C9-41BD-47CD-E7FA615E0D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B271F9-31CD-1902-EBA8-DA008B098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86D128-239F-8C6F-65A3-D01C0615F2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6AC624-25D4-E7DB-21D8-537BAC76F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6CA30B-A26B-28C4-0EF2-B7677E957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260256-91E0-8042-CB78-62503FAE1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7071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E3EBC-70C2-30DD-2553-E7B5FD6D60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888F5F-282E-C742-E25A-2B13E2C24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090E12-41CD-F36C-E68F-4D9ED4D7B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2C91A0-AE8A-1938-90D0-25FBB1A95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2860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21331B5-19FE-BC92-B464-B6223286A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4A855F-D68C-1163-0676-9782E1C4D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51EFF5-F862-8A2E-30C0-A9894118B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099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26A657-1561-DF66-0494-EE4E40EF23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C39250-9407-680C-7A5B-41B0CEA66D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1267A0-CA46-5EFB-B56A-6D2163B3F4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1AFF91-2EAF-988B-9C82-7D4E52A1F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0B719B-D040-7B61-47C3-C3A8E24DC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AEA1DF-3477-4B4A-86EA-03386F0CD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3979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55A5B9-B3FB-5AB2-DA3D-F1116991C0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0BE279-543B-8512-BA3D-C650366618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4DE732-489E-341D-2267-6912B17DC7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B22C6-CDC9-66C7-788F-E15B05838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7CCF70-E166-7D24-5280-4EA0F1A36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9AB381-266C-06F0-4CAA-932B5AD6C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27063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88FF24-1D30-1D53-DAAA-C0F8704B6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83355C-FCCB-EEFB-8BE2-89A5FB2BF2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3C7FA-531B-718C-1307-7A312E23C4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AEA289-FC76-4A4C-831E-EB20093A1216}" type="datetimeFigureOut">
              <a:rPr lang="en-AU" smtClean="0"/>
              <a:t>22/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B99F01-A81D-F3C7-C93A-44122E8172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9900C6-9ED1-5E20-5B7A-BB1D5C20C0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797497C-C48F-4A26-8D75-A47155822B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31297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F609FF9A-4FCE-468E-A86A-C9AB525EAE7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-1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21E12D4-3A88-428D-8E5E-AF1AFD923D6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5" name="Picture 4" descr="The radiologic figure of a skeleton">
            <a:extLst>
              <a:ext uri="{FF2B5EF4-FFF2-40B4-BE49-F238E27FC236}">
                <a16:creationId xmlns:a16="http://schemas.microsoft.com/office/drawing/2014/main" id="{01A33658-F888-72C3-0928-5177309A8D31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 amt="60000"/>
          </a:blip>
          <a:srcRect t="14264" b="830"/>
          <a:stretch/>
        </p:blipFill>
        <p:spPr>
          <a:xfrm>
            <a:off x="-1" y="10"/>
            <a:ext cx="12192001" cy="685799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4FC73921-A4BD-6795-AFB7-257FFD6369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38200" y="914402"/>
            <a:ext cx="10515600" cy="2985923"/>
          </a:xfrm>
        </p:spPr>
        <p:txBody>
          <a:bodyPr>
            <a:normAutofit/>
          </a:bodyPr>
          <a:lstStyle/>
          <a:p>
            <a:r>
              <a:rPr lang="en-AU" sz="5200" dirty="0">
                <a:solidFill>
                  <a:srgbClr val="FFFFFF"/>
                </a:solidFill>
              </a:rPr>
              <a:t>UPPER LIMB MUSCULOSKELETAL EXAMINATIO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99E3A8-9D4F-034E-F87C-7790AD6D97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38200" y="4072040"/>
            <a:ext cx="10515600" cy="1384310"/>
          </a:xfrm>
        </p:spPr>
        <p:txBody>
          <a:bodyPr>
            <a:normAutofit/>
          </a:bodyPr>
          <a:lstStyle/>
          <a:p>
            <a:r>
              <a:rPr lang="en-AU" dirty="0">
                <a:solidFill>
                  <a:srgbClr val="FFFFFF"/>
                </a:solidFill>
              </a:rPr>
              <a:t>Kevin Qian </a:t>
            </a:r>
          </a:p>
          <a:p>
            <a:r>
              <a:rPr lang="en-AU" dirty="0">
                <a:solidFill>
                  <a:srgbClr val="FFFFFF"/>
                </a:solidFill>
              </a:rPr>
              <a:t>A/Prof. Keran Sundaraj FRACS </a:t>
            </a:r>
            <a:r>
              <a:rPr lang="en-AU" dirty="0" err="1">
                <a:solidFill>
                  <a:srgbClr val="FFFFFF"/>
                </a:solidFill>
              </a:rPr>
              <a:t>FAOrthA</a:t>
            </a:r>
            <a:r>
              <a:rPr lang="en-AU" dirty="0">
                <a:solidFill>
                  <a:srgbClr val="FFFFFF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016657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7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15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7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0" presetClass="entr" presetSubtype="0" fill="hold" grpId="0" nodeType="clickEffect">
                                  <p:stCondLst>
                                    <p:cond delay="15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7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3" grpId="0" build="p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78ED2-BCAB-4F1A-EBC9-038A5B384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Elbow RO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0F8EE7-506B-B1CE-95DD-7C19216D75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/>
              <a:t>AROM:</a:t>
            </a:r>
          </a:p>
          <a:p>
            <a:pPr lvl="1"/>
            <a:r>
              <a:rPr lang="en-AU" dirty="0"/>
              <a:t>Flexion and extension: 0-150</a:t>
            </a:r>
          </a:p>
          <a:p>
            <a:pPr lvl="1"/>
            <a:r>
              <a:rPr lang="en-AU" dirty="0"/>
              <a:t>Supination: 80-90 </a:t>
            </a:r>
          </a:p>
          <a:p>
            <a:pPr lvl="1"/>
            <a:r>
              <a:rPr lang="en-AU" dirty="0"/>
              <a:t>Pronation: 70-85 </a:t>
            </a:r>
          </a:p>
          <a:p>
            <a:pPr marL="457200" lvl="1" indent="0">
              <a:buNone/>
            </a:pPr>
            <a:endParaRPr lang="en-AU" dirty="0"/>
          </a:p>
          <a:p>
            <a:r>
              <a:rPr lang="en-AU" dirty="0"/>
              <a:t>PROM:</a:t>
            </a:r>
          </a:p>
          <a:p>
            <a:pPr lvl="1"/>
            <a:r>
              <a:rPr lang="en-AU" dirty="0"/>
              <a:t>Assess for stiffness and crepitus</a:t>
            </a:r>
          </a:p>
          <a:p>
            <a:pPr lvl="1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2207560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F24123-D4B5-A172-4909-01155CB3D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Elbow anatomy</a:t>
            </a: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1FDE8E61-8458-195A-C112-BFCB2000F1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1073" y="1690688"/>
            <a:ext cx="9849853" cy="46337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1520393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83C479-365A-3ED8-FC2D-4AB07E16FE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Elbow anatomy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36B568D-A025-A814-9B35-E00DA1A28F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52534" y="365125"/>
            <a:ext cx="3401266" cy="62662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F49E5B6-4C9B-AF20-6EB9-2E28B81C8F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0087" y="2566486"/>
            <a:ext cx="6524625" cy="2847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798497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FB9F37-89B9-E780-46EE-E03EAA197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Elbow specific tes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C1A7C7-CACA-A638-096E-54103BCE30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AU" b="1" dirty="0"/>
              <a:t>Tennis elbow (lateral epicondylitis/</a:t>
            </a:r>
            <a:r>
              <a:rPr lang="en-AU" b="1" dirty="0" err="1"/>
              <a:t>lalgia</a:t>
            </a:r>
            <a:r>
              <a:rPr lang="en-AU" b="1" dirty="0"/>
              <a:t>)</a:t>
            </a:r>
          </a:p>
          <a:p>
            <a:pPr lvl="1"/>
            <a:r>
              <a:rPr lang="en-AU" b="1" dirty="0" err="1"/>
              <a:t>Cozen’s</a:t>
            </a:r>
            <a:r>
              <a:rPr lang="en-AU" b="1" dirty="0"/>
              <a:t> test (resisted wrist extension)</a:t>
            </a:r>
          </a:p>
          <a:p>
            <a:pPr lvl="1"/>
            <a:r>
              <a:rPr lang="en-AU" b="1" dirty="0"/>
              <a:t>Maudsley’s test (resisted 3</a:t>
            </a:r>
            <a:r>
              <a:rPr lang="en-AU" b="1" baseline="30000" dirty="0"/>
              <a:t>rd</a:t>
            </a:r>
            <a:r>
              <a:rPr lang="en-AU" b="1" dirty="0"/>
              <a:t> digit extension + palpation of lateral epicondyle)</a:t>
            </a:r>
          </a:p>
          <a:p>
            <a:r>
              <a:rPr lang="en-AU" dirty="0"/>
              <a:t>Golfer’s elbow (medial epicondylitis/</a:t>
            </a:r>
            <a:r>
              <a:rPr lang="en-AU" dirty="0" err="1"/>
              <a:t>lalgia</a:t>
            </a:r>
            <a:r>
              <a:rPr lang="en-AU" dirty="0"/>
              <a:t>)</a:t>
            </a:r>
          </a:p>
          <a:p>
            <a:pPr lvl="1"/>
            <a:r>
              <a:rPr lang="en-AU" dirty="0"/>
              <a:t>Reverse </a:t>
            </a:r>
            <a:r>
              <a:rPr lang="en-AU" dirty="0" err="1"/>
              <a:t>Cozen’s</a:t>
            </a:r>
            <a:r>
              <a:rPr lang="en-AU" dirty="0"/>
              <a:t> test (resisted wrist flexion)</a:t>
            </a:r>
          </a:p>
          <a:p>
            <a:r>
              <a:rPr lang="en-AU" dirty="0"/>
              <a:t>Ligamentous injury </a:t>
            </a:r>
          </a:p>
          <a:p>
            <a:pPr lvl="1"/>
            <a:r>
              <a:rPr lang="en-AU" dirty="0"/>
              <a:t>MCL stress test</a:t>
            </a:r>
          </a:p>
          <a:p>
            <a:pPr lvl="1"/>
            <a:r>
              <a:rPr lang="en-AU" dirty="0"/>
              <a:t>LCL stress test</a:t>
            </a:r>
          </a:p>
          <a:p>
            <a:r>
              <a:rPr lang="en-AU" dirty="0"/>
              <a:t>Cubital tunnel syndrome</a:t>
            </a:r>
          </a:p>
          <a:p>
            <a:pPr lvl="1"/>
            <a:r>
              <a:rPr lang="en-AU" dirty="0"/>
              <a:t>Tinel’s test </a:t>
            </a:r>
          </a:p>
          <a:p>
            <a:pPr marL="457200" lvl="1" indent="0">
              <a:buNone/>
            </a:pP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60546100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BA2076-7999-EAF2-5FFC-8BEDC135A3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/>
          <a:lstStyle/>
          <a:p>
            <a:pPr algn="ctr"/>
            <a:r>
              <a:rPr lang="en-AU" dirty="0"/>
              <a:t>EXTRAS</a:t>
            </a:r>
          </a:p>
        </p:txBody>
      </p:sp>
    </p:spTree>
    <p:extLst>
      <p:ext uri="{BB962C8B-B14F-4D97-AF65-F5344CB8AC3E}">
        <p14:creationId xmlns:p14="http://schemas.microsoft.com/office/powerpoint/2010/main" val="76776046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4599B0-1163-B5FF-BB04-52B1D92CF9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Wrist palp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9486EA-F865-1CED-9A1C-33978A4C4C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AU" dirty="0"/>
              <a:t>Radial styloid</a:t>
            </a:r>
          </a:p>
          <a:p>
            <a:r>
              <a:rPr lang="en-AU" dirty="0"/>
              <a:t>Ulnar styloid</a:t>
            </a:r>
          </a:p>
          <a:p>
            <a:r>
              <a:rPr lang="en-AU" dirty="0"/>
              <a:t>Dorsal and palmar joint lines</a:t>
            </a:r>
          </a:p>
          <a:p>
            <a:r>
              <a:rPr lang="en-AU" dirty="0"/>
              <a:t>Scaphoid tubercle</a:t>
            </a:r>
          </a:p>
          <a:p>
            <a:r>
              <a:rPr lang="en-AU" dirty="0"/>
              <a:t>Pisiform</a:t>
            </a:r>
          </a:p>
          <a:p>
            <a:r>
              <a:rPr lang="en-AU" dirty="0"/>
              <a:t>Hook of hamate</a:t>
            </a:r>
          </a:p>
          <a:p>
            <a:r>
              <a:rPr lang="en-AU" dirty="0"/>
              <a:t>Anatomical snuffbox </a:t>
            </a:r>
          </a:p>
          <a:p>
            <a:pPr lvl="1"/>
            <a:r>
              <a:rPr lang="en-AU" dirty="0"/>
              <a:t>Scaphoid waist</a:t>
            </a:r>
          </a:p>
          <a:p>
            <a:pPr lvl="1"/>
            <a:r>
              <a:rPr lang="en-AU" dirty="0"/>
              <a:t>Bordered by tendons of EPL (ulnar border) and EPB/APL (radial border)</a:t>
            </a:r>
          </a:p>
          <a:p>
            <a:r>
              <a:rPr lang="en-AU" dirty="0"/>
              <a:t>Fovea sign (triangle fibrocartilaginous complex TFCC)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41540656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A85C2-E06C-DCE4-A44C-94074C6F29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Wrist surface anatomy</a:t>
            </a:r>
          </a:p>
        </p:txBody>
      </p:sp>
      <p:pic>
        <p:nvPicPr>
          <p:cNvPr id="5122" name="Picture 2">
            <a:extLst>
              <a:ext uri="{FF2B5EF4-FFF2-40B4-BE49-F238E27FC236}">
                <a16:creationId xmlns:a16="http://schemas.microsoft.com/office/drawing/2014/main" id="{845D5549-8830-3C9D-B270-1710FC9CA8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8338" y="366584"/>
            <a:ext cx="4042610" cy="61248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2E52BF1-28A5-BD9E-6097-D98FC59F88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3894" y="1584582"/>
            <a:ext cx="5238750" cy="4905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433418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4F2CD6-F21D-5118-60F8-BEC86579DD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Wrist RO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499DA2-5D5F-452C-70F8-1411C2404D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/>
              <a:t>AROM</a:t>
            </a:r>
          </a:p>
          <a:p>
            <a:pPr lvl="1"/>
            <a:r>
              <a:rPr lang="en-AU" dirty="0"/>
              <a:t>Flexion: 70-90 </a:t>
            </a:r>
          </a:p>
          <a:p>
            <a:pPr lvl="1"/>
            <a:r>
              <a:rPr lang="en-AU" dirty="0"/>
              <a:t>Extension: 60-70</a:t>
            </a:r>
          </a:p>
          <a:p>
            <a:pPr lvl="1"/>
            <a:r>
              <a:rPr lang="en-AU" dirty="0"/>
              <a:t>Radial deviation: 15-20</a:t>
            </a:r>
          </a:p>
          <a:p>
            <a:pPr lvl="1"/>
            <a:r>
              <a:rPr lang="en-AU" dirty="0"/>
              <a:t>Ulnar deviation: 30-45</a:t>
            </a:r>
          </a:p>
          <a:p>
            <a:r>
              <a:rPr lang="en-AU" dirty="0"/>
              <a:t>PROM</a:t>
            </a:r>
          </a:p>
          <a:p>
            <a:pPr lvl="1"/>
            <a:r>
              <a:rPr lang="en-AU" dirty="0"/>
              <a:t>Stiffness and crepitus</a:t>
            </a:r>
          </a:p>
          <a:p>
            <a:pPr marL="457200" lvl="1" indent="0">
              <a:buNone/>
            </a:pP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52971772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20371E-2233-5469-0BFB-3B7D9DB758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Wrist specific tes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FDB2D6-C95A-7E18-536E-099300C73A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AU" dirty="0"/>
              <a:t>Carpal tunnel syndrome (median nerve entrapment under flexor retinaculum)</a:t>
            </a:r>
          </a:p>
          <a:p>
            <a:pPr lvl="1"/>
            <a:r>
              <a:rPr lang="en-AU" dirty="0"/>
              <a:t>Phalen’s test</a:t>
            </a:r>
          </a:p>
          <a:p>
            <a:pPr lvl="1"/>
            <a:r>
              <a:rPr lang="en-AU" dirty="0"/>
              <a:t>Tinel’s test</a:t>
            </a:r>
          </a:p>
          <a:p>
            <a:r>
              <a:rPr lang="en-AU" dirty="0" err="1"/>
              <a:t>DeQuervain’s</a:t>
            </a:r>
            <a:r>
              <a:rPr lang="en-AU" dirty="0"/>
              <a:t> tenosynovitis (inflammation of the tendons and tendon sheath within the 1</a:t>
            </a:r>
            <a:r>
              <a:rPr lang="en-AU" baseline="30000" dirty="0"/>
              <a:t>st</a:t>
            </a:r>
            <a:r>
              <a:rPr lang="en-AU" dirty="0"/>
              <a:t> dorsal wrist compartment under the extensor retinaculum – involves EPB and APL tendons)</a:t>
            </a:r>
          </a:p>
          <a:p>
            <a:pPr lvl="1"/>
            <a:r>
              <a:rPr lang="en-AU" dirty="0"/>
              <a:t>Finkelstein’s test</a:t>
            </a:r>
          </a:p>
          <a:p>
            <a:r>
              <a:rPr lang="en-AU" dirty="0"/>
              <a:t>Scaphoid fracture/scapholunate instability</a:t>
            </a:r>
          </a:p>
          <a:p>
            <a:pPr lvl="1"/>
            <a:r>
              <a:rPr lang="en-AU" dirty="0"/>
              <a:t>Scaphoid compression test</a:t>
            </a:r>
          </a:p>
          <a:p>
            <a:pPr lvl="1"/>
            <a:r>
              <a:rPr lang="en-AU" dirty="0"/>
              <a:t>Watson’s test (scaphoid shift) </a:t>
            </a:r>
          </a:p>
          <a:p>
            <a:r>
              <a:rPr lang="en-AU" dirty="0"/>
              <a:t>TFCC injury</a:t>
            </a:r>
          </a:p>
          <a:p>
            <a:pPr lvl="1"/>
            <a:r>
              <a:rPr lang="en-AU" dirty="0"/>
              <a:t>Fovea sign</a:t>
            </a:r>
          </a:p>
          <a:p>
            <a:pPr lvl="1"/>
            <a:r>
              <a:rPr lang="en-AU" dirty="0"/>
              <a:t>TFCC compression test</a:t>
            </a:r>
          </a:p>
          <a:p>
            <a:pPr lvl="1"/>
            <a:r>
              <a:rPr lang="en-AU" dirty="0"/>
              <a:t>TFCC tension test</a:t>
            </a:r>
          </a:p>
          <a:p>
            <a:pPr lvl="1"/>
            <a:r>
              <a:rPr lang="en-AU" dirty="0"/>
              <a:t>Supination lift test</a:t>
            </a:r>
          </a:p>
          <a:p>
            <a:pPr lvl="1"/>
            <a:endParaRPr lang="en-AU" dirty="0"/>
          </a:p>
          <a:p>
            <a:pPr marL="457200" lvl="1" indent="0">
              <a:buNone/>
            </a:pPr>
            <a:endParaRPr lang="en-AU" dirty="0"/>
          </a:p>
          <a:p>
            <a:pPr lvl="1"/>
            <a:endParaRPr lang="en-AU" dirty="0"/>
          </a:p>
          <a:p>
            <a:pPr marL="457200" lvl="1" indent="0">
              <a:buNone/>
            </a:pPr>
            <a:endParaRPr lang="en-AU" dirty="0"/>
          </a:p>
          <a:p>
            <a:pPr marL="457200" lvl="1" indent="0">
              <a:buNone/>
            </a:pP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619645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3547C3-D7C0-B94F-1345-37A54D271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Beginn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4E2A45-FCE4-6BA9-3633-1BFE2031FE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/>
              <a:t>Introduce yourself and where you are from</a:t>
            </a:r>
          </a:p>
          <a:p>
            <a:r>
              <a:rPr lang="en-AU" dirty="0"/>
              <a:t>Explain what you are going to do </a:t>
            </a:r>
          </a:p>
          <a:p>
            <a:r>
              <a:rPr lang="en-AU" dirty="0"/>
              <a:t>Gain consent</a:t>
            </a:r>
          </a:p>
          <a:p>
            <a:pPr marL="0" indent="0">
              <a:buNone/>
            </a:pP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9315607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231809-9283-64CE-F225-A24F91D94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Inspec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766052-5DF4-80D9-1F7A-43FE6ACAFE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AU" dirty="0"/>
              <a:t>General</a:t>
            </a:r>
          </a:p>
          <a:p>
            <a:pPr lvl="1"/>
            <a:r>
              <a:rPr lang="en-AU" dirty="0"/>
              <a:t>Pain</a:t>
            </a:r>
          </a:p>
          <a:p>
            <a:pPr lvl="1"/>
            <a:r>
              <a:rPr lang="en-AU" dirty="0"/>
              <a:t>Environment: walking/mobility aids, splints/braces</a:t>
            </a:r>
          </a:p>
          <a:p>
            <a:pPr lvl="1"/>
            <a:r>
              <a:rPr lang="en-AU" dirty="0"/>
              <a:t>General posture at rest </a:t>
            </a:r>
          </a:p>
          <a:p>
            <a:pPr lvl="1"/>
            <a:r>
              <a:rPr lang="en-AU" dirty="0"/>
              <a:t>Scars, rashes, effusion/swelling, erythema, wounds</a:t>
            </a:r>
          </a:p>
          <a:p>
            <a:r>
              <a:rPr lang="en-AU" dirty="0"/>
              <a:t>Limb</a:t>
            </a:r>
          </a:p>
          <a:p>
            <a:pPr lvl="1"/>
            <a:r>
              <a:rPr lang="en-AU" dirty="0"/>
              <a:t>Posture</a:t>
            </a:r>
          </a:p>
          <a:p>
            <a:pPr lvl="1"/>
            <a:r>
              <a:rPr lang="en-AU" dirty="0"/>
              <a:t>Asymmetry</a:t>
            </a:r>
          </a:p>
          <a:p>
            <a:pPr lvl="1"/>
            <a:r>
              <a:rPr lang="en-AU" dirty="0"/>
              <a:t>Wasting</a:t>
            </a:r>
          </a:p>
          <a:p>
            <a:pPr lvl="1"/>
            <a:r>
              <a:rPr lang="en-AU" dirty="0"/>
              <a:t>Effusion/swelling</a:t>
            </a:r>
          </a:p>
          <a:p>
            <a:pPr lvl="1"/>
            <a:r>
              <a:rPr lang="en-AU" dirty="0"/>
              <a:t>Erythema</a:t>
            </a:r>
          </a:p>
          <a:p>
            <a:pPr lvl="1"/>
            <a:r>
              <a:rPr lang="en-AU" dirty="0"/>
              <a:t>Scars/rashes</a:t>
            </a:r>
          </a:p>
          <a:p>
            <a:pPr lvl="1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2845347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4609D6-F884-2A2D-5E47-0A7B627F9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Shoulder palpa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C1E0409-DF19-7F91-0719-6BA47EC7FC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8273" y="1524810"/>
            <a:ext cx="8935453" cy="4968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95141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701C6E-A761-DC86-DB24-DC876AF23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Shoulder RO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F738DC-6D87-E5F4-40C6-FCA9F881AA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AU" dirty="0"/>
              <a:t>Active ROM</a:t>
            </a:r>
          </a:p>
          <a:p>
            <a:pPr lvl="1"/>
            <a:r>
              <a:rPr lang="en-AU" dirty="0"/>
              <a:t>Flexion: 180</a:t>
            </a:r>
          </a:p>
          <a:p>
            <a:pPr lvl="1"/>
            <a:r>
              <a:rPr lang="en-AU" dirty="0"/>
              <a:t>Extension: 65</a:t>
            </a:r>
          </a:p>
          <a:p>
            <a:pPr lvl="1"/>
            <a:r>
              <a:rPr lang="en-AU" dirty="0"/>
              <a:t>Abduction: 160-180 </a:t>
            </a:r>
          </a:p>
          <a:p>
            <a:pPr lvl="1"/>
            <a:r>
              <a:rPr lang="en-AU" dirty="0"/>
              <a:t>Adduction: 50</a:t>
            </a:r>
          </a:p>
          <a:p>
            <a:pPr lvl="1"/>
            <a:r>
              <a:rPr lang="en-AU" dirty="0"/>
              <a:t>Internal rotation: 70-90</a:t>
            </a:r>
          </a:p>
          <a:p>
            <a:pPr lvl="1"/>
            <a:r>
              <a:rPr lang="en-AU" dirty="0"/>
              <a:t>External rotation: 90</a:t>
            </a:r>
          </a:p>
          <a:p>
            <a:r>
              <a:rPr lang="en-AU" dirty="0"/>
              <a:t>Passive ROM</a:t>
            </a:r>
          </a:p>
          <a:p>
            <a:pPr lvl="1"/>
            <a:r>
              <a:rPr lang="en-AU" dirty="0"/>
              <a:t>Assess for stiffness and crepitus through all planes of movement</a:t>
            </a:r>
          </a:p>
          <a:p>
            <a:r>
              <a:rPr lang="en-AU" dirty="0"/>
              <a:t>Always compare sides, some movements can be done at the same time</a:t>
            </a:r>
          </a:p>
          <a:p>
            <a:pPr marL="0" indent="0">
              <a:buNone/>
            </a:pPr>
            <a:endParaRPr lang="en-AU" dirty="0"/>
          </a:p>
          <a:p>
            <a:pPr marL="457200" lvl="1" indent="0">
              <a:buNone/>
            </a:pP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8359055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F314A-F654-811E-70B9-CEE4D45905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Subacromial space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652E6B12-F1CB-C12C-CE9F-59D662298A8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8005" y="1434223"/>
            <a:ext cx="5375989" cy="50586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56157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89681-FAC5-F284-C136-D3FFDD0DC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Rotator cuff </a:t>
            </a:r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id="{1C4ACACD-9190-4635-2D79-6D3B6E2339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1926" y="1443790"/>
            <a:ext cx="9328148" cy="46640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20443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E8D094-B1A6-397D-EA92-A6FB24B51E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Shoulder specific tests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926EA8-B2CB-006C-E6B3-E1D3FAE2D0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r>
              <a:rPr lang="en-AU" b="1" dirty="0"/>
              <a:t>Subacromial pathology/impingement:</a:t>
            </a:r>
          </a:p>
          <a:p>
            <a:pPr lvl="1"/>
            <a:r>
              <a:rPr lang="en-AU" b="1" dirty="0"/>
              <a:t>Hawkins-Kennedy</a:t>
            </a:r>
          </a:p>
          <a:p>
            <a:pPr lvl="1"/>
            <a:r>
              <a:rPr lang="en-AU" b="1" dirty="0"/>
              <a:t>Painful arc</a:t>
            </a:r>
          </a:p>
          <a:p>
            <a:r>
              <a:rPr lang="en-AU" b="1" dirty="0"/>
              <a:t>Stability:</a:t>
            </a:r>
          </a:p>
          <a:p>
            <a:pPr lvl="1"/>
            <a:r>
              <a:rPr lang="en-AU" b="1" dirty="0"/>
              <a:t>Apprehension test for anterior instability</a:t>
            </a:r>
          </a:p>
          <a:p>
            <a:pPr lvl="2"/>
            <a:r>
              <a:rPr lang="en-AU" b="1" dirty="0"/>
              <a:t>Augmentation, relocation and release </a:t>
            </a:r>
          </a:p>
          <a:p>
            <a:pPr lvl="1"/>
            <a:r>
              <a:rPr lang="en-AU" b="1" dirty="0"/>
              <a:t>Sulcus sign for inferior instability</a:t>
            </a:r>
          </a:p>
          <a:p>
            <a:r>
              <a:rPr lang="en-AU" dirty="0"/>
              <a:t>Rotator cuff injury</a:t>
            </a:r>
          </a:p>
          <a:p>
            <a:pPr lvl="1"/>
            <a:r>
              <a:rPr lang="en-AU" dirty="0"/>
              <a:t>Drop arm sign</a:t>
            </a:r>
          </a:p>
          <a:p>
            <a:pPr lvl="1"/>
            <a:r>
              <a:rPr lang="en-AU" dirty="0"/>
              <a:t>External rotation lag sign</a:t>
            </a:r>
          </a:p>
          <a:p>
            <a:pPr lvl="1"/>
            <a:r>
              <a:rPr lang="en-AU" dirty="0"/>
              <a:t>Belly press test</a:t>
            </a:r>
          </a:p>
          <a:p>
            <a:pPr lvl="1"/>
            <a:r>
              <a:rPr lang="en-AU" dirty="0"/>
              <a:t>Lift off test</a:t>
            </a:r>
          </a:p>
          <a:p>
            <a:r>
              <a:rPr lang="en-AU" dirty="0"/>
              <a:t>Labral tear/pathology</a:t>
            </a:r>
          </a:p>
          <a:p>
            <a:pPr lvl="1"/>
            <a:r>
              <a:rPr lang="en-AU" dirty="0"/>
              <a:t>O’Brien’s test</a:t>
            </a:r>
          </a:p>
          <a:p>
            <a:r>
              <a:rPr lang="en-AU" dirty="0"/>
              <a:t>AC joint sprain</a:t>
            </a:r>
          </a:p>
          <a:p>
            <a:pPr lvl="1"/>
            <a:r>
              <a:rPr lang="en-AU" dirty="0"/>
              <a:t>Horizontal adduction test</a:t>
            </a:r>
          </a:p>
          <a:p>
            <a:pPr lvl="1"/>
            <a:r>
              <a:rPr lang="en-AU" dirty="0"/>
              <a:t>ACJ compression test</a:t>
            </a:r>
          </a:p>
          <a:p>
            <a:pPr lvl="1"/>
            <a:endParaRPr lang="en-AU" dirty="0"/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6943254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8273B-F56B-6BC3-E541-3CFBECC90B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Elbow palpa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BB4C4D9-E25E-6741-3B2C-1839F76C40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04838" y="1690688"/>
            <a:ext cx="4782324" cy="4565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6672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692</Words>
  <Application>Microsoft Macintosh PowerPoint</Application>
  <PresentationFormat>Widescreen</PresentationFormat>
  <Paragraphs>139</Paragraphs>
  <Slides>1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3" baseType="lpstr">
      <vt:lpstr>Aptos</vt:lpstr>
      <vt:lpstr>Aptos Display</vt:lpstr>
      <vt:lpstr>Arial</vt:lpstr>
      <vt:lpstr>Calibri</vt:lpstr>
      <vt:lpstr>Office Theme</vt:lpstr>
      <vt:lpstr>UPPER LIMB MUSCULOSKELETAL EXAMINATION</vt:lpstr>
      <vt:lpstr>Beginning</vt:lpstr>
      <vt:lpstr>Inspection</vt:lpstr>
      <vt:lpstr>Shoulder palpation</vt:lpstr>
      <vt:lpstr>Shoulder ROM</vt:lpstr>
      <vt:lpstr>Subacromial space</vt:lpstr>
      <vt:lpstr>Rotator cuff </vt:lpstr>
      <vt:lpstr>Shoulder specific tests </vt:lpstr>
      <vt:lpstr>Elbow palpation</vt:lpstr>
      <vt:lpstr>Elbow ROM</vt:lpstr>
      <vt:lpstr>Elbow anatomy</vt:lpstr>
      <vt:lpstr>Elbow anatomy</vt:lpstr>
      <vt:lpstr>Elbow specific tests</vt:lpstr>
      <vt:lpstr>EXTRAS</vt:lpstr>
      <vt:lpstr>Wrist palpation</vt:lpstr>
      <vt:lpstr>Wrist surface anatomy</vt:lpstr>
      <vt:lpstr>Wrist ROM</vt:lpstr>
      <vt:lpstr>Wrist specific test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vin Qian</dc:creator>
  <cp:lastModifiedBy>Kevin Qian</cp:lastModifiedBy>
  <cp:revision>3</cp:revision>
  <dcterms:created xsi:type="dcterms:W3CDTF">2025-04-06T06:30:35Z</dcterms:created>
  <dcterms:modified xsi:type="dcterms:W3CDTF">2026-01-21T15:32:54Z</dcterms:modified>
</cp:coreProperties>
</file>